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75" r:id="rId3"/>
    <p:sldId id="276" r:id="rId4"/>
    <p:sldId id="277" r:id="rId5"/>
    <p:sldId id="278" r:id="rId6"/>
    <p:sldId id="279" r:id="rId7"/>
    <p:sldId id="280" r:id="rId8"/>
    <p:sldId id="281" r:id="rId9"/>
    <p:sldId id="282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0" autoAdjust="0"/>
    <p:restoredTop sz="94660"/>
  </p:normalViewPr>
  <p:slideViewPr>
    <p:cSldViewPr snapToGrid="0">
      <p:cViewPr varScale="1">
        <p:scale>
          <a:sx n="93" d="100"/>
          <a:sy n="93" d="100"/>
        </p:scale>
        <p:origin x="92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2BD9C7-FBC1-7CC3-16C6-33FA128339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391F82F-24DF-AB29-DE6E-3D10080DF1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628C67-2488-E78D-B322-0964D97FE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849C6-1E93-4DC6-B9F8-5B71DA71371B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63814F-AD07-14E3-85F8-002BF902CB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ED5C81-9E15-45C8-55B0-C5415251A1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324DC-3048-4EDA-9F23-EE13698218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3238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C67B5A-7129-A6DB-1D52-002E1C87AD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4FDBCB-EF7E-B4B6-06FB-6F7A02BEDB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E47CCB-C7B0-3F11-CF30-25C68F039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849C6-1E93-4DC6-B9F8-5B71DA71371B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99ED32-1078-321E-BD05-05DA90B16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1FAF92-8C3B-0050-8BB7-B9A8DEEBE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324DC-3048-4EDA-9F23-EE13698218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1405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DF2E62B-0CEE-66ED-A42B-B52B062E64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EC94B9-5E83-B149-C4B3-0BCFADBFAF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5BDEBA-69CC-C1D7-F2FB-2C235D361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849C6-1E93-4DC6-B9F8-5B71DA71371B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942063-D1D8-64B4-842A-35F0B67C8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8B80CF-7AA6-DBFA-75BF-8D1D0503D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324DC-3048-4EDA-9F23-EE13698218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0799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1446AB-F4D4-AD1C-D61C-BF7D48E294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F751ED-23A7-1988-DD46-18192894A1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56A785-EFD3-0558-530A-AFE163AFE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849C6-1E93-4DC6-B9F8-5B71DA71371B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4A95CE-B07D-5B52-77A7-F00EA9C65F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E6E7AF-4D76-9053-5050-72F16F8C7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324DC-3048-4EDA-9F23-EE13698218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837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C52412-36EC-2197-9842-CD7F324D77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C63355-0191-A048-4CA8-F5330B4A3B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D5DB17-179C-3646-C997-666D6F074D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849C6-1E93-4DC6-B9F8-5B71DA71371B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FE47B9-4A2A-122F-BA31-88AC06978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5DAADE-F694-02B8-0BA1-EACEAC210D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324DC-3048-4EDA-9F23-EE13698218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0304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B85D34-138E-4978-85FA-0B3028DADC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95EDDA-6757-3EEC-2241-AAD265048B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ACF82C-ED7A-286F-E51E-C20DEDAF4D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95B412-3D13-056F-1B21-A58765DB1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849C6-1E93-4DC6-B9F8-5B71DA71371B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DE1494-3672-D7D4-3425-611413631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EB8473-53EA-B4B9-E8D6-90EAEC8F4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324DC-3048-4EDA-9F23-EE13698218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5972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30CF42-2F40-07D7-B25C-7DE8EE716A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503F86-E5C6-175E-6A0F-C953EA059E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4D9537-8402-80FA-B6BB-F6DC7623E8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2636E8A-D9C9-A2E8-57C0-2A26119599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3B90AB7-1FAA-A0BF-C559-1A45DA5C72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701FF23-70EA-61F9-DD2C-5EEECD34A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849C6-1E93-4DC6-B9F8-5B71DA71371B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751EA3-0E8A-8025-6F33-B429A5062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D102421-FE45-8985-9324-256C914149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324DC-3048-4EDA-9F23-EE13698218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6029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D9CAD6-2BDD-FBF7-0008-2A5DA98BC5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A042FEB-4CA9-7E05-DA07-72CA297BB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849C6-1E93-4DC6-B9F8-5B71DA71371B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B97A949-7BDA-32AD-55BB-60D576856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784AED7-6806-36BD-39D1-FF4B46480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324DC-3048-4EDA-9F23-EE13698218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8510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2936479-2718-8969-7C85-DF376AAAF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849C6-1E93-4DC6-B9F8-5B71DA71371B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F3B6F59-2AF1-4725-A628-E97615E30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7ACA24-A328-D07E-EA29-4957CDFAAD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324DC-3048-4EDA-9F23-EE13698218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9150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1D617-73D0-4ED3-4A47-36DC859BE1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9B2C82-8F0B-E20E-16DF-29B3B8D158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AF64FC-363F-4A7D-E4DB-0DFB283A0E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3BCFD4-7A99-B2C3-B97A-E9C86BCE58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849C6-1E93-4DC6-B9F8-5B71DA71371B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948337-ADD2-749B-A6FC-AB83AB8694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31B2C1-4987-DCA6-6907-9B36B3ED1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324DC-3048-4EDA-9F23-EE13698218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5591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E95C80-83E0-4ABD-1261-09A2177CA9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812F8EE-0BD4-B70D-F1A8-DEB56F8F44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708DD6-1FBB-3613-9AB7-9DDE915767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F3B470-8F56-8C5C-FA50-79BE236DC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849C6-1E93-4DC6-B9F8-5B71DA71371B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8DF642-5BF9-E6F1-59DA-2D99C2D65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6CA4E7-4C6C-BA33-20C1-E64A73A29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F324DC-3048-4EDA-9F23-EE13698218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5412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4978211-5B65-170D-8807-808D8542C6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4EF85B-C0BF-8696-24D0-EA2B1D6021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5B477D-499D-8D20-068A-B26DBF19D7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6849C6-1E93-4DC6-B9F8-5B71DA71371B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7BCDAD-B169-E13C-7222-59519DE0D7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5FC9A3-D4B6-DA80-2AD0-19E7656A97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F324DC-3048-4EDA-9F23-EE13698218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3182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73D98A-DEFE-43B0-6CE6-C2FBFA2E4B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ISS in African American children</a:t>
            </a:r>
            <a:endParaRPr lang="en-GB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80DE02E-D0D8-A354-C8E0-EC986B51B7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7153" y="2307907"/>
            <a:ext cx="2943225" cy="96202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2D11562-D6EB-BBC6-3D7A-62392AE992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8200" y="3588069"/>
            <a:ext cx="2266950" cy="294322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A904592-B506-9117-F5BA-C7DA737D86D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16289" y="1280817"/>
            <a:ext cx="7827515" cy="42963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2187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CFB024-20EB-D888-5B78-FB49CF3BFD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RTS in African American children</a:t>
            </a:r>
            <a:endParaRPr lang="en-GB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0A4F5E39-FAED-2C5B-C858-EF0D5018B8A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2032068"/>
            <a:ext cx="2971800" cy="1143000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0837B4C-EEC5-1ADD-4D9D-5AED7AE783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8200" y="3521075"/>
            <a:ext cx="1895475" cy="2971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256E1AB-1C15-87F9-4458-5A0744C459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92384" y="1673135"/>
            <a:ext cx="7175444" cy="3942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35408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E5ADE5-168A-D22F-F907-54DA3DA227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RAGIC+ in African American children</a:t>
            </a:r>
            <a:endParaRPr lang="en-GB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6CBFB48-E8DB-7723-34A3-D541168D38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690688"/>
            <a:ext cx="3209925" cy="123825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28F357B-1307-55D8-56C1-01273C0956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9947" y="3383280"/>
            <a:ext cx="2247900" cy="29337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D9BEED9-8C4C-35C7-6DE6-93460B5B848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35679" y="1681434"/>
            <a:ext cx="6318121" cy="34951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00006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D206C5-2B69-915B-D835-0BF973BA05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ISS in Asian children </a:t>
            </a:r>
            <a:endParaRPr lang="en-GB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3DA1C5F-A7C6-B38E-F8A6-BD6F7AC3A1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9729" y="1690688"/>
            <a:ext cx="3124200" cy="1143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6FC7F98-D4ED-0423-0CEE-2C476E8943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8200" y="3225710"/>
            <a:ext cx="2162175" cy="291465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00B89D2-0DF4-C4E2-A253-4A64DE016C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36492" y="1569493"/>
            <a:ext cx="6363646" cy="37190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70309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1ACFE4-2582-2DED-E3AD-703A7214F0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RTS in Asian children </a:t>
            </a:r>
            <a:endParaRPr lang="en-GB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4AB9A61-8C2F-78D6-26FD-0EA0C2887F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9710" y="2146391"/>
            <a:ext cx="2762250" cy="97155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3849F5C-4D98-1F5F-4DE8-B54122F48C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15922" y="3573644"/>
            <a:ext cx="2409825" cy="28575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ADB003E-0E52-9F97-1B7B-C680D0CEE0F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45256" y="1576547"/>
            <a:ext cx="7191869" cy="43670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07414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ABC88-B72B-3932-B048-89CB26C85B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RAGIC+ in Asian children </a:t>
            </a:r>
            <a:endParaRPr lang="en-GB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6B1BC6A-B8B3-57EF-04B1-8F7D4026F1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0435" y="1592852"/>
            <a:ext cx="2809875" cy="108585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C818844-8A58-26B7-EFD6-0520522302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84348" y="1592852"/>
            <a:ext cx="6346035" cy="398934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9AC6640-579F-CC04-4624-7055BB88FD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3742" y="2918415"/>
            <a:ext cx="2428875" cy="29241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79035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C999C019-5E0E-8BA1-7DEB-5FBF332208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ISS in White children</a:t>
            </a:r>
            <a:endParaRPr lang="en-GB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745B9BF-7AA4-C0E9-8C42-2D5BEE26A2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836737"/>
            <a:ext cx="3228975" cy="115252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15BAD3B-A5F8-5BDA-C85D-D388E9BAE3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6374" y="3262993"/>
            <a:ext cx="1952625" cy="28575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1D4E955-DE15-0942-7D6C-C987B03B25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44114" y="1345141"/>
            <a:ext cx="5961425" cy="38357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45197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47DDBA-D919-30A4-4D01-A2E413BA76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RTS in White children</a:t>
            </a:r>
            <a:endParaRPr lang="en-GB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246F010-572E-7C66-5B0B-04C8A0C4F2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801857"/>
            <a:ext cx="2743200" cy="108585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D4F1AD5-C8FE-1385-F884-50845229F1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3604" y="3429000"/>
            <a:ext cx="2076450" cy="291465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F27D896-7C83-448B-54AD-F75DD69694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64390" y="1295130"/>
            <a:ext cx="6685353" cy="3969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132112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E335B1-7775-C996-54C1-C210BB1F00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RAGIC+ in White children</a:t>
            </a:r>
            <a:endParaRPr lang="en-GB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D6B8A24-CFB4-66E0-119A-4B99B2751E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2649" y="1575026"/>
            <a:ext cx="2924175" cy="109537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C8722C6-E561-EF04-BA55-9D1313721E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0339" y="2774904"/>
            <a:ext cx="1990725" cy="305752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2ED50D6-0C49-6A26-23B2-F6226894DFA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77558" y="1208452"/>
            <a:ext cx="6958539" cy="4147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663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2</Words>
  <Application>Microsoft Office PowerPoint</Application>
  <PresentationFormat>Widescreen</PresentationFormat>
  <Paragraphs>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ISS in African American children</vt:lpstr>
      <vt:lpstr>RTS in African American children</vt:lpstr>
      <vt:lpstr>TRAGIC+ in African American children</vt:lpstr>
      <vt:lpstr>ISS in Asian children </vt:lpstr>
      <vt:lpstr>RTS in Asian children </vt:lpstr>
      <vt:lpstr>TRAGIC+ in Asian children </vt:lpstr>
      <vt:lpstr>ISS in White children</vt:lpstr>
      <vt:lpstr>RTS in White children</vt:lpstr>
      <vt:lpstr>TRAGIC+ in White childre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ace=black ISS</dc:title>
  <dc:creator>alvaro moreira</dc:creator>
  <cp:lastModifiedBy>Alvaro Moreira</cp:lastModifiedBy>
  <cp:revision>2</cp:revision>
  <dcterms:created xsi:type="dcterms:W3CDTF">2023-06-15T02:31:50Z</dcterms:created>
  <dcterms:modified xsi:type="dcterms:W3CDTF">2023-06-15T02:40:19Z</dcterms:modified>
</cp:coreProperties>
</file>